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4E66CE-C503-43E3-8434-6059DC1570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B7427-943E-4976-93F7-5C6B8E49C1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C9D143-C86A-480C-9A58-0EA93C75F9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CCBE4B-6869-4BCC-9106-8E6514A405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B14344-AEC2-4FC9-BEDF-A0C660632B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82D81-BB2E-4C72-B609-63E7245017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68F97C-AF93-45D1-ADC1-8918E04C2C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7D8485-25C1-4696-8285-C38CDC27B6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A90BB-79B8-462B-85CA-668A0B1CC7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A5D1D7-0280-4CD3-BA01-444BECC471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69AF92-FDFD-4274-A191-57D887786B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C4D779-708B-4082-B660-4772B62BFD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7BD0FE-818C-4538-A5A0-7DB780F693D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830160" y="812880"/>
            <a:ext cx="8091360" cy="4726080"/>
            <a:chOff x="830160" y="812880"/>
            <a:chExt cx="8091360" cy="4726080"/>
          </a:xfrm>
        </p:grpSpPr>
        <p:sp>
          <p:nvSpPr>
            <p:cNvPr id="42" name=""/>
            <p:cNvSpPr/>
            <p:nvPr/>
          </p:nvSpPr>
          <p:spPr>
            <a:xfrm>
              <a:off x="844560" y="858960"/>
              <a:ext cx="8076960" cy="4656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" sz="1200" spc="-1" strike="noStrike" u="sng">
                  <a:solidFill>
                    <a:srgbClr val="000000"/>
                  </a:solidFill>
                  <a:uFillTx/>
                  <a:latin typeface="Courier New"/>
                </a:rPr>
                <a:t>AT</a:t>
              </a:r>
              <a:r>
                <a:rPr b="1" lang="en" sz="1200" spc="-1" strike="noStrike" u="sng">
                  <a:solidFill>
                    <a:srgbClr val="ff9900"/>
                  </a:solidFill>
                  <a:uFillTx/>
                  <a:latin typeface="Courier New"/>
                </a:rPr>
                <a:t>G</a:t>
              </a:r>
              <a:r>
                <a:rPr b="1" lang="en" sz="1200" spc="-1" strike="noStrike">
                  <a:solidFill>
                    <a:srgbClr val="ff9900"/>
                  </a:solidFill>
                  <a:latin typeface="Courier New"/>
                </a:rPr>
                <a:t>GCGCGCGAGTCGGCCAGTGCTCGGACCAGCGAGTCGGGGCTGCCCATCGAACCGGTCTA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CGGGCCCGACGCCC</a:t>
              </a:r>
              <a:r>
                <a:rPr b="1" lang="en" sz="1200" spc="-1" strike="noStrike">
                  <a:solidFill>
                    <a:srgbClr val="ff3300"/>
                  </a:solidFill>
                  <a:latin typeface="Courier New"/>
                </a:rPr>
                <a:t>TGGCGGACTGGGACGCGGCCGAGAAGCTGGGCGAGCCCGGGAAGTACCCCTTCACCCGGGGC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GTCTACCCGTCGATGTACACCGGCCGGCCGTGGACGAT</a:t>
              </a:r>
              <a:r>
                <a:rPr b="1" lang="en" sz="1200" spc="-1" strike="noStrike">
                  <a:solidFill>
                    <a:srgbClr val="a50021"/>
                  </a:solidFill>
                  <a:latin typeface="Courier New"/>
                </a:rPr>
                <a:t>GCGCCAGTACGCCGGTTTCGGCACGGCCACGGAGTCCAACGCCCGCTACAAGCAGCTGATC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GCCAACGGCACCATGGGCCTGTCGGTCGCCTTCGACCTGCCCACCCAGATGGGCCACGACTCCGACGCGCCGATCGCGA</a:t>
              </a:r>
              <a:r>
                <a:rPr b="1" lang="en" sz="1200" spc="-1" strike="noStrike">
                  <a:solidFill>
                    <a:srgbClr val="ff0066"/>
                  </a:solidFill>
                  <a:latin typeface="Courier New"/>
                </a:rPr>
                <a:t>GCGGCGAGGTCGGCAAGGTCGGCGTCGCCATCGACTCCATCGACGACATGCGGGTGCTGTT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CGGCGGGATCCCGCTGGAC</a:t>
              </a:r>
              <a:r>
                <a:rPr b="1" lang="en" sz="1200" spc="-1" strike="noStrike">
                  <a:solidFill>
                    <a:srgbClr val="993366"/>
                  </a:solidFill>
                  <a:latin typeface="Courier New"/>
                </a:rPr>
                <a:t>AAGGTCTCCACGTCGATGACGATCAACGCCCCTGCCTCGCTGCTGCTCCTGCTCTACCAAC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TCGTCGCCGAGGAGCAGGG</a:t>
              </a:r>
              <a:r>
                <a:rPr b="1" lang="en" sz="1200" spc="-1" strike="noStrike">
                  <a:solidFill>
                    <a:srgbClr val="cc0099"/>
                  </a:solidFill>
                  <a:latin typeface="Courier New"/>
                </a:rPr>
                <a:t>CGTGAGCGCCGACAAGCTCACCGGCACGATCCAGAACGACGTGCTGAAGGAGTACATCGCG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CGCGGGACGTACATCTTCC</a:t>
              </a:r>
              <a:r>
                <a:rPr b="1" lang="en" sz="1200" spc="-1" strike="noStrike">
                  <a:solidFill>
                    <a:srgbClr val="9900cc"/>
                  </a:solidFill>
                  <a:latin typeface="Courier New"/>
                </a:rPr>
                <a:t>CGCCGAAGCCGTCGCTGCGCCTGATCGCGGACATCTTCAAGTACTGCCGGGCCGAGATCCC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GAAGTGGAACACCATCTC</a:t>
              </a:r>
              <a:r>
                <a:rPr b="1" lang="en" sz="1200" spc="-1" strike="noStrike">
                  <a:solidFill>
                    <a:srgbClr val="6600ff"/>
                  </a:solidFill>
                  <a:latin typeface="Courier New"/>
                </a:rPr>
                <a:t>GATCTCCGGCTACCACATGGCCGAGGCGGGCGCGTCTCCCGCGCAGGAGATCGCGTTCAC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CCTCGCGGACGGCATCGAGTA</a:t>
              </a:r>
              <a:r>
                <a:rPr b="1" lang="en" sz="1200" spc="-1" strike="noStrike">
                  <a:solidFill>
                    <a:srgbClr val="3333ff"/>
                  </a:solidFill>
                  <a:latin typeface="Courier New"/>
                </a:rPr>
                <a:t>CGTGCGCACCGCGGTCGCGGCCGGCATGGACGTGGACGACTTCGCGCCCCGCCTGTCCTTC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TTCTTCGTGGCCCGCACGACGATCCTGGAGGAGGTCGCC</a:t>
              </a:r>
              <a:r>
                <a:rPr b="1" lang="en" sz="1200" spc="-1" strike="noStrike">
                  <a:solidFill>
                    <a:srgbClr val="00ccff"/>
                  </a:solidFill>
                  <a:latin typeface="Courier New"/>
                </a:rPr>
                <a:t>AAGTTCCGCGCGGCCCGCCGGATCTGGGCCCGGGTGATGAAGGAGGAGTTCGGCGCGAAGA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ACCCCAAGTCGCTGATGCTGCGCTTCCACACCCAGACGGCGGGCGTGCAGCTGACCGCCCAGCAGCCCGAGGTGAACCTGGTCCGCGTCGCCGTGCAGG</a:t>
              </a:r>
              <a:r>
                <a:rPr b="1" lang="en" sz="1200" spc="-1" strike="noStrike">
                  <a:solidFill>
                    <a:srgbClr val="339966"/>
                  </a:solidFill>
                  <a:latin typeface="Courier New"/>
                </a:rPr>
                <a:t>GTCTCGGCGCGGTCCTCGGCGGCACGCAGTCGCTGCACACCAACTCCTTCGACGAGGCCAT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CGCGCTGCCCACCGACAAGTCCGCGCGCCTGGCCCTGCG</a:t>
              </a:r>
              <a:r>
                <a:rPr b="1" lang="en" sz="1200" spc="-1" strike="noStrike">
                  <a:solidFill>
                    <a:srgbClr val="00ff00"/>
                  </a:solidFill>
                  <a:latin typeface="Courier New"/>
                </a:rPr>
                <a:t>CACCCAGCAGGTGCTCGCCTACGAGACGGACGTGACGGCGACCGTCGACCCCTTCGCCGGC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TCCTACGTCGTCGAGCGGA</a:t>
              </a:r>
              <a:r>
                <a:rPr b="1" lang="en" sz="1200" spc="-1" strike="noStrike">
                  <a:solidFill>
                    <a:srgbClr val="008000"/>
                  </a:solidFill>
                  <a:latin typeface="Courier New"/>
                </a:rPr>
                <a:t>TGACCGACGACGTCGAGGCGGCGGCGCTGGAGCTGATGGGCAAGGTGGAGGACCTCGGCGG</a:t>
              </a:r>
              <a:r>
                <a:rPr b="1" lang="en" sz="1200" spc="-1" strike="noStrike">
                  <a:solidFill>
                    <a:srgbClr val="99cc00"/>
                  </a:solidFill>
                  <a:latin typeface="Courier New"/>
                </a:rPr>
                <a:t>CGCGGTCAACGCCATCGAGC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ACGGCTTCCAGAAGAACGAGATCGAGCGCTCCGCCTACCGCATCGCCCAGGAGACCGACTCCGGCGAGCGGGTCGTGGTCGGCGTCAACCGCTTCCAGC</a:t>
              </a:r>
              <a:r>
                <a:rPr b="1" lang="en" sz="1200" spc="-1" strike="noStrike">
                  <a:solidFill>
                    <a:srgbClr val="ff9900"/>
                  </a:solidFill>
                  <a:latin typeface="Courier New"/>
                </a:rPr>
                <a:t>TCGACGAGGAGGAGCCCTACGAGCCGCTGCGCGTCGACCCGGCCATCGAGGCCCAGCAGGCC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GAGCGGCTGGCCAAGCTC</a:t>
              </a:r>
              <a:r>
                <a:rPr b="1" lang="en" sz="1200" spc="-1" strike="noStrike">
                  <a:solidFill>
                    <a:srgbClr val="ff0000"/>
                  </a:solidFill>
                  <a:latin typeface="Courier New"/>
                </a:rPr>
                <a:t>CGCGCCGAGCGCGACCAGCAGGCGGTGGACTCGGCACTGGCGGCCCTGAGGAAGGCCGCCG</a:t>
              </a:r>
              <a:r>
                <a:rPr b="1" lang="en" sz="1200" spc="-1" strike="noStrike">
                  <a:solidFill>
                    <a:srgbClr val="a50021"/>
                  </a:solidFill>
                  <a:latin typeface="Courier New"/>
                </a:rPr>
                <a:t>AGGGCGAGGACAACGTCCTGTACCCGATGAAGGACGCGCTG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CGGGCCCGGGCGACGGTGGGCGAGGTGTGCAACGCGCTGCGGGAGGTCTGGGGGACGTACGTGCCCTC</a:t>
              </a:r>
              <a:r>
                <a:rPr b="1" lang="en" sz="1200" spc="-1" strike="noStrike">
                  <a:solidFill>
                    <a:srgbClr val="ff0066"/>
                  </a:solidFill>
                  <a:latin typeface="Courier New"/>
                </a:rPr>
                <a:t>CGATCTC</a:t>
              </a:r>
              <a:r>
                <a:rPr b="1" lang="en" sz="1200" spc="-1" strike="noStrike" u="sng">
                  <a:solidFill>
                    <a:srgbClr val="ff0066"/>
                  </a:solidFill>
                  <a:uFillTx/>
                  <a:latin typeface="Courier New"/>
                </a:rPr>
                <a:t>TAA</a:t>
              </a:r>
              <a:r>
                <a:rPr b="0" lang="en" sz="1200" spc="-1" strike="noStrike">
                  <a:solidFill>
                    <a:srgbClr val="ff0066"/>
                  </a:solidFill>
                  <a:latin typeface="Courier New"/>
                </a:rPr>
                <a:t>GACGAGTGGTCCAATTTGCCTTGCTGAGTGAGGAGTTCATTTC</a:t>
              </a:r>
              <a:r>
                <a:rPr b="1" lang="en" sz="1200" spc="-1" strike="noStrike" u="sng">
                  <a:solidFill>
                    <a:srgbClr val="ff0066"/>
                  </a:solidFill>
                  <a:uFillTx/>
                  <a:latin typeface="Courier New"/>
                </a:rPr>
                <a:t>ATG</a:t>
              </a:r>
              <a:r>
                <a:rPr b="1" lang="en" sz="1200" spc="-1" strike="noStrike">
                  <a:solidFill>
                    <a:srgbClr val="ff0066"/>
                  </a:solidFill>
                  <a:latin typeface="Courier New"/>
                </a:rPr>
                <a:t>CGGCA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GCTACCGATGCGAGTGGTTGTGGCCAAACCTG</a:t>
              </a:r>
              <a:r>
                <a:rPr b="1" lang="en" sz="1200" spc="-1" strike="noStrike">
                  <a:solidFill>
                    <a:srgbClr val="cc0099"/>
                  </a:solidFill>
                  <a:latin typeface="Courier New"/>
                </a:rPr>
                <a:t>GCCTCGACGGTCACGATCGTGGAGCGAAGGTCGTCGCACGAGCTTTGCGTGATGCCGGAGT</a:t>
              </a:r>
              <a:r>
                <a:rPr b="1" lang="en" sz="1200" spc="-1" strike="noStrike">
                  <a:solidFill>
                    <a:srgbClr val="9900cc"/>
                  </a:solidFill>
                  <a:latin typeface="Courier New"/>
                </a:rPr>
                <a:t>GGAAGTCATCTACA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CGGGTCTGCACCAGACGCCGGCGCAGATCGTCGCCACAGCAATCCAGGAAGACGCTGACGGCATCG</a:t>
              </a:r>
              <a:r>
                <a:rPr b="1" lang="en" sz="1200" spc="-1" strike="noStrike">
                  <a:solidFill>
                    <a:srgbClr val="3333cc"/>
                  </a:solidFill>
                  <a:latin typeface="Courier New"/>
                </a:rPr>
                <a:t>GACTATCTGTGCTGTCCGGAGCGCACATGACCGCGTTCACGGAGGTTATGAAGCTGATCCA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GCTGGAGGAGGCGACGAACATTATCGTCTTCGGCGGAG</a:t>
              </a:r>
              <a:r>
                <a:rPr b="1" lang="en" sz="1200" spc="-1" strike="noStrike">
                  <a:solidFill>
                    <a:srgbClr val="00ffff"/>
                  </a:solidFill>
                  <a:latin typeface="Courier New"/>
                </a:rPr>
                <a:t>GCATCATTCCCGATGACGATGCTGCGAACCTCCTCGAAGGGGGAGTCGCGGCCCTATTTAC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ACCGGGGACGTCGATGGCGACGGTGGTCGATTGGGTGAC</a:t>
              </a:r>
              <a:r>
                <a:rPr b="1" lang="en" sz="1200" spc="-1" strike="noStrike">
                  <a:solidFill>
                    <a:srgbClr val="00cc66"/>
                  </a:solidFill>
                  <a:latin typeface="Courier New"/>
                </a:rPr>
                <a:t>GAATCATGTGGGTGGACGGCGAACCGGCCGGGTCTTGGCGCAGCCTGTTCCCCATAGCGCG</a:t>
              </a:r>
              <a:r>
                <a:rPr b="1" lang="en" sz="1200" spc="-1" strike="noStrike">
                  <a:solidFill>
                    <a:srgbClr val="000000"/>
                  </a:solidFill>
                  <a:latin typeface="Courier New"/>
                </a:rPr>
                <a:t>CAGGCTGCTCCTGCTGGGCCCTTCCAACGAAGCCGT</a:t>
              </a:r>
              <a:r>
                <a:rPr b="1" lang="en" sz="1200" spc="-1" strike="noStrike" u="sng">
                  <a:solidFill>
                    <a:srgbClr val="000000"/>
                  </a:solidFill>
                  <a:uFillTx/>
                  <a:latin typeface="Courier New"/>
                </a:rPr>
                <a:t>TGA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857160" y="4581360"/>
              <a:ext cx="8001000" cy="957600"/>
            </a:xfrm>
            <a:prstGeom prst="rect">
              <a:avLst/>
            </a:prstGeom>
            <a:solidFill>
              <a:srgbClr val="ff6600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384200" y="4378320"/>
              <a:ext cx="7435800" cy="200160"/>
            </a:xfrm>
            <a:prstGeom prst="rect">
              <a:avLst/>
            </a:prstGeom>
            <a:solidFill>
              <a:srgbClr val="ff6600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839880" y="4195800"/>
              <a:ext cx="4487760" cy="185760"/>
            </a:xfrm>
            <a:prstGeom prst="rect">
              <a:avLst/>
            </a:prstGeom>
            <a:solidFill>
              <a:srgbClr val="ff6600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830160" y="812880"/>
              <a:ext cx="8001000" cy="3381120"/>
            </a:xfrm>
            <a:prstGeom prst="rect">
              <a:avLst/>
            </a:prstGeom>
            <a:solidFill>
              <a:srgbClr val="ff6600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0" y="312840"/>
            <a:ext cx="8959680" cy="4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dditional File 4: Microarray probes encompass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SCO6832-SCO683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5960" y="860400"/>
            <a:ext cx="82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ourier New"/>
              </a:rPr>
              <a:t>SCO683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440" y="4344840"/>
            <a:ext cx="82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ourier New"/>
              </a:rPr>
              <a:t>SCO683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09T10:42:12Z</dcterms:created>
  <dc:creator>Lewis</dc:creator>
  <dc:description/>
  <dc:language>en-US</dc:language>
  <cp:lastModifiedBy>Lewis</cp:lastModifiedBy>
  <dcterms:modified xsi:type="dcterms:W3CDTF">2010-09-24T14:17:53Z</dcterms:modified>
  <cp:revision>9</cp:revision>
  <dc:subject/>
  <dc:title>Slide 1</dc:title>
</cp:coreProperties>
</file>